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4008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670" autoAdjust="0"/>
  </p:normalViewPr>
  <p:slideViewPr>
    <p:cSldViewPr snapToGrid="0" snapToObjects="1">
      <p:cViewPr>
        <p:scale>
          <a:sx n="201" d="100"/>
          <a:sy n="201" d="100"/>
        </p:scale>
        <p:origin x="-1480" y="8128"/>
      </p:cViewPr>
      <p:guideLst>
        <p:guide orient="horz" pos="3456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3408681"/>
            <a:ext cx="5440680" cy="23520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6217920"/>
            <a:ext cx="448056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576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64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703582"/>
            <a:ext cx="1007903" cy="1497837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703582"/>
            <a:ext cx="2917032" cy="1497837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82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406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7051041"/>
            <a:ext cx="5440680" cy="21793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4650742"/>
            <a:ext cx="5440680" cy="24002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021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4097022"/>
            <a:ext cx="1962468" cy="115849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4097022"/>
            <a:ext cx="1962468" cy="115849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094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439421"/>
            <a:ext cx="5760720" cy="18288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2456181"/>
            <a:ext cx="2828132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3479800"/>
            <a:ext cx="2828132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2456181"/>
            <a:ext cx="2829243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3479800"/>
            <a:ext cx="2829243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486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780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295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436880"/>
            <a:ext cx="2105819" cy="18592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436881"/>
            <a:ext cx="3578225" cy="93649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2296161"/>
            <a:ext cx="2105819" cy="75057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286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7680960"/>
            <a:ext cx="3840480" cy="9067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980440"/>
            <a:ext cx="3840480" cy="65836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8587741"/>
            <a:ext cx="3840480" cy="12877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461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439421"/>
            <a:ext cx="5760720" cy="1828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2560321"/>
            <a:ext cx="5760720" cy="72415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10170161"/>
            <a:ext cx="149352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F5F90-2B85-104E-94A8-81643D960B2A}" type="datetimeFigureOut">
              <a:rPr lang="en-US" smtClean="0"/>
              <a:t>1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10170161"/>
            <a:ext cx="202692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10170161"/>
            <a:ext cx="149352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A2331-E8E6-9441-8D97-337355ECE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264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Untitle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400800" cy="349642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43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(A)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890" y="3499686"/>
            <a:ext cx="43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(B)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79563" y="7768338"/>
            <a:ext cx="172084" cy="170751"/>
          </a:xfrm>
          <a:prstGeom prst="rect">
            <a:avLst/>
          </a:prstGeom>
          <a:solidFill>
            <a:srgbClr val="21FD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79563" y="7991130"/>
            <a:ext cx="172084" cy="170751"/>
          </a:xfrm>
          <a:prstGeom prst="rect">
            <a:avLst/>
          </a:prstGeom>
          <a:solidFill>
            <a:srgbClr val="F645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51647" y="7713622"/>
            <a:ext cx="1123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cidobacteri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1647" y="7938188"/>
            <a:ext cx="1165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ctinobacteri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9563" y="8216513"/>
            <a:ext cx="172084" cy="170751"/>
          </a:xfrm>
          <a:prstGeom prst="rect">
            <a:avLst/>
          </a:prstGeom>
          <a:solidFill>
            <a:srgbClr val="FF0000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79563" y="8444534"/>
            <a:ext cx="172084" cy="170751"/>
          </a:xfrm>
          <a:prstGeom prst="rect">
            <a:avLst/>
          </a:prstGeom>
          <a:solidFill>
            <a:srgbClr val="0000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1428045" y="7768338"/>
            <a:ext cx="172084" cy="170751"/>
          </a:xfrm>
          <a:prstGeom prst="rect">
            <a:avLst/>
          </a:prstGeom>
          <a:solidFill>
            <a:srgbClr val="185D5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1428045" y="8447881"/>
            <a:ext cx="172084" cy="170751"/>
          </a:xfrm>
          <a:prstGeom prst="rect">
            <a:avLst/>
          </a:prstGeom>
          <a:solidFill>
            <a:srgbClr val="E29B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865330" y="7991130"/>
            <a:ext cx="172084" cy="170751"/>
          </a:xfrm>
          <a:prstGeom prst="rect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4417999" y="7764045"/>
            <a:ext cx="172084" cy="170751"/>
          </a:xfrm>
          <a:prstGeom prst="rect">
            <a:avLst/>
          </a:prstGeom>
          <a:solidFill>
            <a:srgbClr val="77773B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251647" y="8166982"/>
            <a:ext cx="9949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Ascomycot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61613" y="8390779"/>
            <a:ext cx="1079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Bacteroidetes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609652" y="7713622"/>
            <a:ext cx="1153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Basidiomycot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605955" y="8393041"/>
            <a:ext cx="1271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Chytridiomycot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46752" y="7933265"/>
            <a:ext cx="6046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Fungi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90083" y="7710204"/>
            <a:ext cx="9891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Zygomycot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4" name="Oval 23"/>
          <p:cNvSpPr/>
          <p:nvPr/>
        </p:nvSpPr>
        <p:spPr>
          <a:xfrm>
            <a:off x="4828729" y="8126035"/>
            <a:ext cx="195397" cy="196375"/>
          </a:xfrm>
          <a:prstGeom prst="ellipse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5023410" y="8078013"/>
            <a:ext cx="7685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Bacteri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6" name="Isosceles Triangle 25"/>
          <p:cNvSpPr/>
          <p:nvPr/>
        </p:nvSpPr>
        <p:spPr>
          <a:xfrm>
            <a:off x="4835156" y="8449496"/>
            <a:ext cx="188970" cy="188969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5023410" y="8388619"/>
            <a:ext cx="6046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Fungi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1430613" y="8216513"/>
            <a:ext cx="172084" cy="170751"/>
          </a:xfrm>
          <a:prstGeom prst="rect">
            <a:avLst/>
          </a:prstGeom>
          <a:solidFill>
            <a:srgbClr val="31FF34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2862516" y="7770974"/>
            <a:ext cx="172084" cy="170751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2865330" y="8216513"/>
            <a:ext cx="172084" cy="170751"/>
          </a:xfrm>
          <a:prstGeom prst="rect">
            <a:avLst/>
          </a:prstGeom>
          <a:solidFill>
            <a:srgbClr val="FFFF00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2862516" y="8444534"/>
            <a:ext cx="172084" cy="170751"/>
          </a:xfrm>
          <a:prstGeom prst="rect">
            <a:avLst/>
          </a:prstGeom>
          <a:solidFill>
            <a:srgbClr val="008000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1611781" y="8152034"/>
            <a:ext cx="932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Chloroflexi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043240" y="7710204"/>
            <a:ext cx="903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Firmicutes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040676" y="8148576"/>
            <a:ext cx="145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Gemmatimonadetes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040676" y="8385917"/>
            <a:ext cx="1086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Protebacteri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1429295" y="7991130"/>
            <a:ext cx="172084" cy="170751"/>
          </a:xfrm>
          <a:prstGeom prst="rect">
            <a:avLst/>
          </a:prstGeom>
          <a:solidFill>
            <a:srgbClr val="FF0000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1608777" y="7934369"/>
            <a:ext cx="980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Chlamydiae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-4024" y="9203087"/>
            <a:ext cx="641601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smtClean="0">
                <a:latin typeface="Times New Roman"/>
                <a:cs typeface="Times New Roman"/>
              </a:rPr>
              <a:t>S3. </a:t>
            </a:r>
            <a:r>
              <a:rPr lang="en-US" sz="1200" dirty="0" smtClean="0">
                <a:latin typeface="Times New Roman"/>
                <a:cs typeface="Times New Roman"/>
              </a:rPr>
              <a:t>Co</a:t>
            </a:r>
            <a:r>
              <a:rPr lang="en-US" sz="1200" dirty="0">
                <a:latin typeface="Times New Roman"/>
                <a:cs typeface="Times New Roman"/>
              </a:rPr>
              <a:t>-occurrence network generated by measuring abundance co-correlation between microbial taxa from </a:t>
            </a:r>
            <a:r>
              <a:rPr lang="en-US" sz="1200" dirty="0" smtClean="0">
                <a:latin typeface="Times New Roman"/>
                <a:cs typeface="Times New Roman"/>
              </a:rPr>
              <a:t>bulk (A) and plastic-associated (B) compost. </a:t>
            </a:r>
            <a:r>
              <a:rPr lang="en-US" sz="1200" dirty="0">
                <a:latin typeface="Times New Roman"/>
                <a:cs typeface="Times New Roman"/>
              </a:rPr>
              <a:t>Correlation base network analysis showing potential interactions between </a:t>
            </a:r>
            <a:r>
              <a:rPr lang="en-US" sz="1200" dirty="0" smtClean="0">
                <a:latin typeface="Times New Roman"/>
                <a:cs typeface="Times New Roman"/>
              </a:rPr>
              <a:t>bacterial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and fungal genera</a:t>
            </a:r>
            <a:r>
              <a:rPr lang="en-US" sz="1200" dirty="0">
                <a:latin typeface="Times New Roman"/>
                <a:cs typeface="Times New Roman"/>
              </a:rPr>
              <a:t>. The size of the node is proportional to a taxon’s average relative abundance across all the samples. The lines connecting nodes (</a:t>
            </a:r>
            <a:r>
              <a:rPr lang="en-US" sz="1200" dirty="0" smtClean="0">
                <a:latin typeface="Times New Roman"/>
                <a:cs typeface="Times New Roman"/>
              </a:rPr>
              <a:t>edges/associations) </a:t>
            </a:r>
            <a:r>
              <a:rPr lang="en-US" sz="1200" dirty="0">
                <a:latin typeface="Times New Roman"/>
                <a:cs typeface="Times New Roman"/>
              </a:rPr>
              <a:t>represent positive (blue) or negative (red) co-occurrence relationship. </a:t>
            </a:r>
            <a:r>
              <a:rPr lang="en-US" sz="1200" dirty="0" smtClean="0">
                <a:latin typeface="Times New Roman"/>
                <a:cs typeface="Times New Roman"/>
              </a:rPr>
              <a:t>The solid lines indicate niche-specific edges and lines with separate errors indicate edges common for both co-occurrence networks. The nodes with back borders are common for </a:t>
            </a:r>
            <a:r>
              <a:rPr lang="en-US" sz="1200" dirty="0">
                <a:latin typeface="Times New Roman"/>
                <a:cs typeface="Times New Roman"/>
              </a:rPr>
              <a:t>both </a:t>
            </a:r>
            <a:r>
              <a:rPr lang="en-US" sz="1200" dirty="0" smtClean="0">
                <a:latin typeface="Times New Roman"/>
                <a:cs typeface="Times New Roman"/>
              </a:rPr>
              <a:t>networks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</a:p>
        </p:txBody>
      </p:sp>
      <p:pic>
        <p:nvPicPr>
          <p:cNvPr id="3" name="Picture 2" descr="Untitled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024" y="3961214"/>
            <a:ext cx="6400800" cy="3496423"/>
          </a:xfrm>
          <a:prstGeom prst="rect">
            <a:avLst/>
          </a:prstGeom>
        </p:spPr>
      </p:pic>
      <p:sp>
        <p:nvSpPr>
          <p:cNvPr id="4" name="Oval 3"/>
          <p:cNvSpPr/>
          <p:nvPr/>
        </p:nvSpPr>
        <p:spPr>
          <a:xfrm>
            <a:off x="3888539" y="1102002"/>
            <a:ext cx="617770" cy="69875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90083" y="1362387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1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59" name="Oval 58"/>
          <p:cNvSpPr/>
          <p:nvPr/>
        </p:nvSpPr>
        <p:spPr>
          <a:xfrm>
            <a:off x="2721362" y="1890293"/>
            <a:ext cx="617770" cy="62971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/>
          <p:cNvSpPr txBox="1"/>
          <p:nvPr/>
        </p:nvSpPr>
        <p:spPr>
          <a:xfrm>
            <a:off x="3422906" y="2150677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2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1" name="Oval 60"/>
          <p:cNvSpPr/>
          <p:nvPr/>
        </p:nvSpPr>
        <p:spPr>
          <a:xfrm rot="1885618">
            <a:off x="1719317" y="2578150"/>
            <a:ext cx="853026" cy="49095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2491641" y="2672409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3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3" name="Oval 62"/>
          <p:cNvSpPr/>
          <p:nvPr/>
        </p:nvSpPr>
        <p:spPr>
          <a:xfrm rot="18273215">
            <a:off x="1264192" y="964961"/>
            <a:ext cx="853026" cy="49095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/>
          <p:cNvSpPr txBox="1"/>
          <p:nvPr/>
        </p:nvSpPr>
        <p:spPr>
          <a:xfrm rot="21597353">
            <a:off x="434025" y="737456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4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5" name="Oval 64"/>
          <p:cNvSpPr/>
          <p:nvPr/>
        </p:nvSpPr>
        <p:spPr>
          <a:xfrm>
            <a:off x="3778295" y="6271140"/>
            <a:ext cx="490845" cy="50880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/>
          <p:cNvSpPr txBox="1"/>
          <p:nvPr/>
        </p:nvSpPr>
        <p:spPr>
          <a:xfrm>
            <a:off x="4352915" y="6531524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1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7" name="Oval 66"/>
          <p:cNvSpPr/>
          <p:nvPr/>
        </p:nvSpPr>
        <p:spPr>
          <a:xfrm>
            <a:off x="2933850" y="4330661"/>
            <a:ext cx="617770" cy="62971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>
            <a:off x="3635394" y="4591045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4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9" name="Oval 68"/>
          <p:cNvSpPr/>
          <p:nvPr/>
        </p:nvSpPr>
        <p:spPr>
          <a:xfrm>
            <a:off x="1149598" y="4712357"/>
            <a:ext cx="845084" cy="62971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874988" y="4369186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3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71" name="Oval 70"/>
          <p:cNvSpPr/>
          <p:nvPr/>
        </p:nvSpPr>
        <p:spPr>
          <a:xfrm>
            <a:off x="2274479" y="6064238"/>
            <a:ext cx="488420" cy="60846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TextBox 71"/>
          <p:cNvSpPr txBox="1"/>
          <p:nvPr/>
        </p:nvSpPr>
        <p:spPr>
          <a:xfrm>
            <a:off x="1280055" y="5980620"/>
            <a:ext cx="931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luster 2</a:t>
            </a:r>
            <a:endParaRPr lang="en-US" sz="16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70558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8</TotalTime>
  <Words>158</Words>
  <Application>Microsoft Macintosh PowerPoint</Application>
  <PresentationFormat>Custom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vetlana Yurgel</dc:creator>
  <cp:lastModifiedBy>Svetlana Yurgel</cp:lastModifiedBy>
  <cp:revision>20</cp:revision>
  <dcterms:created xsi:type="dcterms:W3CDTF">2018-07-24T18:20:47Z</dcterms:created>
  <dcterms:modified xsi:type="dcterms:W3CDTF">2019-01-19T20:43:16Z</dcterms:modified>
</cp:coreProperties>
</file>